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 snapToGrid="0" showGuides="1">
      <p:cViewPr>
        <p:scale>
          <a:sx n="100" d="100"/>
          <a:sy n="100" d="100"/>
        </p:scale>
        <p:origin x="1594" y="-242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C76AE-AE05-4205-A034-EADDC1D75517}" type="datetimeFigureOut">
              <a:rPr lang="en-IN" smtClean="0"/>
              <a:t>03-12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EAB02-6CF5-4D85-A74B-BA5F91F6E07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768776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C76AE-AE05-4205-A034-EADDC1D75517}" type="datetimeFigureOut">
              <a:rPr lang="en-IN" smtClean="0"/>
              <a:t>03-12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EAB02-6CF5-4D85-A74B-BA5F91F6E07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154958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C76AE-AE05-4205-A034-EADDC1D75517}" type="datetimeFigureOut">
              <a:rPr lang="en-IN" smtClean="0"/>
              <a:t>03-12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EAB02-6CF5-4D85-A74B-BA5F91F6E07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405649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C76AE-AE05-4205-A034-EADDC1D75517}" type="datetimeFigureOut">
              <a:rPr lang="en-IN" smtClean="0"/>
              <a:t>03-12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EAB02-6CF5-4D85-A74B-BA5F91F6E07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025260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C76AE-AE05-4205-A034-EADDC1D75517}" type="datetimeFigureOut">
              <a:rPr lang="en-IN" smtClean="0"/>
              <a:t>03-12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EAB02-6CF5-4D85-A74B-BA5F91F6E07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676003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C76AE-AE05-4205-A034-EADDC1D75517}" type="datetimeFigureOut">
              <a:rPr lang="en-IN" smtClean="0"/>
              <a:t>03-12-202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EAB02-6CF5-4D85-A74B-BA5F91F6E07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820987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C76AE-AE05-4205-A034-EADDC1D75517}" type="datetimeFigureOut">
              <a:rPr lang="en-IN" smtClean="0"/>
              <a:t>03-12-2025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EAB02-6CF5-4D85-A74B-BA5F91F6E07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619749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C76AE-AE05-4205-A034-EADDC1D75517}" type="datetimeFigureOut">
              <a:rPr lang="en-IN" smtClean="0"/>
              <a:t>03-12-2025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EAB02-6CF5-4D85-A74B-BA5F91F6E07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765259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C76AE-AE05-4205-A034-EADDC1D75517}" type="datetimeFigureOut">
              <a:rPr lang="en-IN" smtClean="0"/>
              <a:t>03-12-2025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EAB02-6CF5-4D85-A74B-BA5F91F6E07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21771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C76AE-AE05-4205-A034-EADDC1D75517}" type="datetimeFigureOut">
              <a:rPr lang="en-IN" smtClean="0"/>
              <a:t>03-12-202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EAB02-6CF5-4D85-A74B-BA5F91F6E07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505997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C76AE-AE05-4205-A034-EADDC1D75517}" type="datetimeFigureOut">
              <a:rPr lang="en-IN" smtClean="0"/>
              <a:t>03-12-202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EAB02-6CF5-4D85-A74B-BA5F91F6E07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766097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36C76AE-AE05-4205-A034-EADDC1D75517}" type="datetimeFigureOut">
              <a:rPr lang="en-IN" smtClean="0"/>
              <a:t>03-12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C8EAB02-6CF5-4D85-A74B-BA5F91F6E07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876617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4D304AA8-A74A-D012-FD61-9854AEAEA89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6861" y="259307"/>
            <a:ext cx="5984278" cy="8911988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5FA6B38C-EF01-ADAF-D332-577C571514F9}"/>
              </a:ext>
            </a:extLst>
          </p:cNvPr>
          <p:cNvSpPr/>
          <p:nvPr/>
        </p:nvSpPr>
        <p:spPr>
          <a:xfrm>
            <a:off x="1462496" y="2405849"/>
            <a:ext cx="4460875" cy="10477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81E1D670-DF32-0580-1D35-F3964F2B8A97}"/>
              </a:ext>
            </a:extLst>
          </p:cNvPr>
          <p:cNvSpPr/>
          <p:nvPr/>
        </p:nvSpPr>
        <p:spPr>
          <a:xfrm>
            <a:off x="827414" y="4639098"/>
            <a:ext cx="5397659" cy="10477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42D77A9F-4ECF-BF8A-F3A0-6A594BFCB5EA}"/>
              </a:ext>
            </a:extLst>
          </p:cNvPr>
          <p:cNvSpPr/>
          <p:nvPr/>
        </p:nvSpPr>
        <p:spPr>
          <a:xfrm>
            <a:off x="879803" y="6862821"/>
            <a:ext cx="5397659" cy="10477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5A1C436B-DD01-3EB0-5241-347E577754CF}"/>
              </a:ext>
            </a:extLst>
          </p:cNvPr>
          <p:cNvSpPr/>
          <p:nvPr/>
        </p:nvSpPr>
        <p:spPr>
          <a:xfrm>
            <a:off x="875835" y="9095086"/>
            <a:ext cx="5397659" cy="10477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69A5722-0948-90AF-0457-28F957B45025}"/>
              </a:ext>
            </a:extLst>
          </p:cNvPr>
          <p:cNvSpPr txBox="1"/>
          <p:nvPr/>
        </p:nvSpPr>
        <p:spPr>
          <a:xfrm>
            <a:off x="4755232" y="2375333"/>
            <a:ext cx="8120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800" dirty="0">
                <a:solidFill>
                  <a:srgbClr val="FF0000"/>
                </a:solidFill>
              </a:rPr>
              <a:t>R(R,P,S)(x)</a:t>
            </a:r>
            <a:r>
              <a:rPr lang="en-IN" sz="800" baseline="-25000" dirty="0">
                <a:solidFill>
                  <a:srgbClr val="FF0000"/>
                </a:solidFill>
              </a:rPr>
              <a:t>8</a:t>
            </a:r>
            <a:r>
              <a:rPr lang="en-IN" sz="800" dirty="0">
                <a:solidFill>
                  <a:srgbClr val="FF0000"/>
                </a:solidFill>
              </a:rPr>
              <a:t>W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F524ECFF-E7DD-D522-B18B-69A8EE18E317}"/>
              </a:ext>
            </a:extLst>
          </p:cNvPr>
          <p:cNvSpPr/>
          <p:nvPr/>
        </p:nvSpPr>
        <p:spPr>
          <a:xfrm>
            <a:off x="4859473" y="435042"/>
            <a:ext cx="594000" cy="1980000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48F3F3C-5CED-63B2-D4A3-13F77AE15F9B}"/>
              </a:ext>
            </a:extLst>
          </p:cNvPr>
          <p:cNvSpPr txBox="1"/>
          <p:nvPr/>
        </p:nvSpPr>
        <p:spPr>
          <a:xfrm>
            <a:off x="5180803" y="9056430"/>
            <a:ext cx="4822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800" dirty="0" err="1">
                <a:solidFill>
                  <a:srgbClr val="FF0000"/>
                </a:solidFill>
              </a:rPr>
              <a:t>DDxxD</a:t>
            </a:r>
            <a:endParaRPr lang="en-IN" sz="800" dirty="0">
              <a:solidFill>
                <a:srgbClr val="FF0000"/>
              </a:solidFill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B9CA72AB-920C-F802-F7EE-88403A657C04}"/>
              </a:ext>
            </a:extLst>
          </p:cNvPr>
          <p:cNvSpPr/>
          <p:nvPr/>
        </p:nvSpPr>
        <p:spPr>
          <a:xfrm>
            <a:off x="5277381" y="7110753"/>
            <a:ext cx="270000" cy="1980000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7" name="Isosceles Triangle 16">
            <a:extLst>
              <a:ext uri="{FF2B5EF4-FFF2-40B4-BE49-F238E27FC236}">
                <a16:creationId xmlns:a16="http://schemas.microsoft.com/office/drawing/2014/main" id="{948A2524-4114-4D01-286B-F62D70754D52}"/>
              </a:ext>
            </a:extLst>
          </p:cNvPr>
          <p:cNvSpPr/>
          <p:nvPr/>
        </p:nvSpPr>
        <p:spPr>
          <a:xfrm rot="10800000" flipH="1">
            <a:off x="4832619" y="353407"/>
            <a:ext cx="53708" cy="46300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607189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64CF4DD7-80AF-BF99-4BCA-144BAD3B95E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5600" y="453585"/>
            <a:ext cx="5986800" cy="6688096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1ECAA7B8-A298-2735-EBAD-86BF0BE6C920}"/>
              </a:ext>
            </a:extLst>
          </p:cNvPr>
          <p:cNvSpPr/>
          <p:nvPr/>
        </p:nvSpPr>
        <p:spPr>
          <a:xfrm>
            <a:off x="888920" y="2599361"/>
            <a:ext cx="5397659" cy="10477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46BDF26B-A885-9C05-D3D1-43D6B23CB7A8}"/>
              </a:ext>
            </a:extLst>
          </p:cNvPr>
          <p:cNvSpPr/>
          <p:nvPr/>
        </p:nvSpPr>
        <p:spPr>
          <a:xfrm>
            <a:off x="798428" y="4828481"/>
            <a:ext cx="5397659" cy="10477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D1720B0C-99A3-E055-3FC7-06E02B6C51F7}"/>
              </a:ext>
            </a:extLst>
          </p:cNvPr>
          <p:cNvSpPr/>
          <p:nvPr/>
        </p:nvSpPr>
        <p:spPr>
          <a:xfrm>
            <a:off x="939549" y="7065478"/>
            <a:ext cx="3351522" cy="10477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8B25D933-F970-B5F8-4972-BE80854A96DB}"/>
              </a:ext>
            </a:extLst>
          </p:cNvPr>
          <p:cNvSpPr/>
          <p:nvPr/>
        </p:nvSpPr>
        <p:spPr>
          <a:xfrm>
            <a:off x="3571870" y="2853243"/>
            <a:ext cx="486000" cy="1980000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593BE2C-6B0A-D7CE-20FF-FEC1F234853D}"/>
              </a:ext>
            </a:extLst>
          </p:cNvPr>
          <p:cNvSpPr txBox="1"/>
          <p:nvPr/>
        </p:nvSpPr>
        <p:spPr>
          <a:xfrm>
            <a:off x="3519786" y="4815186"/>
            <a:ext cx="5901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800" dirty="0">
                <a:solidFill>
                  <a:srgbClr val="FF0000"/>
                </a:solidFill>
              </a:rPr>
              <a:t>NSE/DTE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DD4C4C8-F88B-4E79-0483-66A43AE1DD14}"/>
              </a:ext>
            </a:extLst>
          </p:cNvPr>
          <p:cNvSpPr txBox="1"/>
          <p:nvPr/>
        </p:nvSpPr>
        <p:spPr>
          <a:xfrm>
            <a:off x="209550" y="7298793"/>
            <a:ext cx="6438900" cy="11695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  <a:tabLst>
                <a:tab pos="3829050" algn="l"/>
              </a:tabLst>
            </a:pPr>
            <a:r>
              <a:rPr lang="en-IN" sz="1000" b="1" dirty="0">
                <a:latin typeface="Palatino Linotype" panose="02040502050505030304" pitchFamily="18" charset="0"/>
                <a:cs typeface="Arial" panose="020B0604020202020204" pitchFamily="34" charset="0"/>
              </a:rPr>
              <a:t>Figure S6</a:t>
            </a:r>
            <a:r>
              <a:rPr lang="en-IN" sz="1000" b="1" kern="100" dirty="0"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. </a:t>
            </a:r>
            <a:r>
              <a:rPr lang="en-IN" sz="1000" kern="100" dirty="0"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Amino acid sequence alignment of 17 MJ-induced </a:t>
            </a:r>
            <a:r>
              <a:rPr lang="en-IN" sz="1000" i="1" kern="100" dirty="0"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LsTPS</a:t>
            </a:r>
            <a:r>
              <a:rPr lang="en-IN" sz="1000" kern="100" dirty="0"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genes. The conserved domain, R(R,S)(x)</a:t>
            </a:r>
            <a:r>
              <a:rPr lang="en-IN" sz="1000" kern="100" baseline="-25000" dirty="0"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8</a:t>
            </a:r>
            <a:r>
              <a:rPr lang="en-IN" sz="1000" kern="100" dirty="0"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W, common for mono-TPS and positionally preserved in some sesqui-TPS; An Asp-rich motif, </a:t>
            </a:r>
            <a:r>
              <a:rPr lang="en-IN" sz="1000" kern="100" dirty="0" err="1"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DDxxD</a:t>
            </a:r>
            <a:r>
              <a:rPr lang="en-IN" sz="1000" kern="100" dirty="0"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for mono, sesqui TPS and NSE/DTE motif necessary for the binding of divalent cation, are shown. Shading is based on conserved similarity as 100% (black); 60% (dark </a:t>
            </a:r>
            <a:r>
              <a:rPr lang="en-IN" sz="1000" kern="100" dirty="0" err="1"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gray</a:t>
            </a:r>
            <a:r>
              <a:rPr lang="en-IN" sz="1000" kern="100" dirty="0"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); and 30% (light </a:t>
            </a:r>
            <a:r>
              <a:rPr lang="en-IN" sz="1000" kern="100" dirty="0" err="1"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gray</a:t>
            </a:r>
            <a:r>
              <a:rPr lang="en-IN" sz="1000" kern="100" dirty="0"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). Sequence alignment was prepared using </a:t>
            </a:r>
            <a:r>
              <a:rPr lang="en-IN" sz="1000" kern="100" dirty="0" err="1"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ClustalW</a:t>
            </a:r>
            <a:r>
              <a:rPr lang="en-IN" sz="1000" kern="100" dirty="0"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and </a:t>
            </a:r>
            <a:r>
              <a:rPr lang="en-IN" sz="1000" kern="100" dirty="0" err="1"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GeneDoc</a:t>
            </a:r>
            <a:r>
              <a:rPr lang="en-IN" sz="1000" kern="100" dirty="0"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. Black triangle indicates the site of truncation for putative signal peptide of corresponding TPS. Abbreviations: </a:t>
            </a:r>
            <a:r>
              <a:rPr lang="en-IN" sz="1000" i="1" kern="100" dirty="0"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Ls, Lactuca sativa; At, Arabidopsis thaliana;</a:t>
            </a:r>
            <a:r>
              <a:rPr lang="en-IN" sz="1000" kern="100" dirty="0"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</a:t>
            </a:r>
            <a:r>
              <a:rPr lang="en-US" sz="1000" i="1" kern="100" dirty="0">
                <a:latin typeface="Palatino Linotype" panose="0204050205050503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Cs, Cannabis sativa; </a:t>
            </a:r>
            <a:r>
              <a:rPr lang="en-US" sz="1000" kern="100" dirty="0">
                <a:latin typeface="Palatino Linotype" panose="0204050205050503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and</a:t>
            </a:r>
            <a:r>
              <a:rPr lang="en-US" sz="1000" i="1" kern="100" dirty="0">
                <a:latin typeface="Palatino Linotype" panose="0204050205050503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 </a:t>
            </a:r>
            <a:r>
              <a:rPr lang="en-US" sz="1000" i="1" kern="100" dirty="0" err="1">
                <a:latin typeface="Palatino Linotype" panose="0204050205050503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Sl</a:t>
            </a:r>
            <a:r>
              <a:rPr lang="en-US" sz="1000" i="1" kern="100" dirty="0">
                <a:latin typeface="Palatino Linotype" panose="0204050205050503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, Solanum </a:t>
            </a:r>
            <a:r>
              <a:rPr lang="en-US" sz="1000" i="1" kern="100" dirty="0" err="1">
                <a:latin typeface="Palatino Linotype" panose="0204050205050503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lycopersicum</a:t>
            </a:r>
            <a:r>
              <a:rPr lang="en-US" sz="1000" i="1" kern="100" dirty="0">
                <a:latin typeface="Palatino Linotype" panose="0204050205050503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.</a:t>
            </a:r>
            <a:endParaRPr lang="en-IN" sz="1000" kern="100" dirty="0">
              <a:latin typeface="Palatino Linotype" panose="02040502050505030304" pitchFamily="18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382442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</TotalTime>
  <Words>150</Words>
  <Application>Microsoft Office PowerPoint</Application>
  <PresentationFormat>A4 Paper (210x297 mm)</PresentationFormat>
  <Paragraphs>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Palatino Linotype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khileshwar Singh</dc:creator>
  <cp:lastModifiedBy>Sungbeom Lee</cp:lastModifiedBy>
  <cp:revision>13</cp:revision>
  <dcterms:created xsi:type="dcterms:W3CDTF">2025-11-18T09:02:51Z</dcterms:created>
  <dcterms:modified xsi:type="dcterms:W3CDTF">2025-12-03T03:38:51Z</dcterms:modified>
</cp:coreProperties>
</file>